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9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BF8D4-228D-44B0-9D2D-0A07BAA2601A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4F188-3A52-4A2C-8174-E8E6E7FE65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BF8D4-228D-44B0-9D2D-0A07BAA2601A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4F188-3A52-4A2C-8174-E8E6E7FE65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BF8D4-228D-44B0-9D2D-0A07BAA2601A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4F188-3A52-4A2C-8174-E8E6E7FE65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BF8D4-228D-44B0-9D2D-0A07BAA2601A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4F188-3A52-4A2C-8174-E8E6E7FE65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BF8D4-228D-44B0-9D2D-0A07BAA2601A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4F188-3A52-4A2C-8174-E8E6E7FE65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BF8D4-228D-44B0-9D2D-0A07BAA2601A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4F188-3A52-4A2C-8174-E8E6E7FE65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BF8D4-228D-44B0-9D2D-0A07BAA2601A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4F188-3A52-4A2C-8174-E8E6E7FE65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BF8D4-228D-44B0-9D2D-0A07BAA2601A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4F188-3A52-4A2C-8174-E8E6E7FE65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BF8D4-228D-44B0-9D2D-0A07BAA2601A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4F188-3A52-4A2C-8174-E8E6E7FE65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BF8D4-228D-44B0-9D2D-0A07BAA2601A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4F188-3A52-4A2C-8174-E8E6E7FE65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BF8D4-228D-44B0-9D2D-0A07BAA2601A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4F188-3A52-4A2C-8174-E8E6E7FE65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5BF8D4-228D-44B0-9D2D-0A07BAA2601A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94F188-3A52-4A2C-8174-E8E6E7FE650A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16789199"/>
              </p:ext>
            </p:extLst>
          </p:nvPr>
        </p:nvGraphicFramePr>
        <p:xfrm>
          <a:off x="762000" y="436880"/>
          <a:ext cx="7467600" cy="60096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33400"/>
                <a:gridCol w="1066800"/>
                <a:gridCol w="990600"/>
                <a:gridCol w="1066800"/>
                <a:gridCol w="3810000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err="1" smtClean="0">
                          <a:latin typeface="Arial" pitchFamily="34" charset="0"/>
                          <a:cs typeface="Arial" pitchFamily="34" charset="0"/>
                        </a:rPr>
                        <a:t>Sl.No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Probe set ID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Fold change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Gene symbol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Gene title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92883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.38459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Igfbp5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Insulin-like growth factor binding protein 5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8694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82695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</a:t>
                      </a:r>
                      <a:r>
                        <a:rPr lang="en-IN" sz="10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appa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regnancy-associated plasma protein A, </a:t>
                      </a:r>
                      <a:r>
                        <a:rPr lang="en-IN" sz="1000" b="0" i="0" kern="1200" dirty="0" err="1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appalysin</a:t>
                      </a:r>
                      <a:r>
                        <a:rPr lang="en-I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 1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7864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70967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Wnt5a 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Wingless-type MMTV integration site family, member 5A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85694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43654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</a:t>
                      </a:r>
                      <a:r>
                        <a:rPr lang="en-IN" sz="10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Tgfa</a:t>
                      </a:r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Transforming growth factor alpha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70788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34816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Igf1r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Insulin –like growth factor 1 receptor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82140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30631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</a:t>
                      </a:r>
                      <a:r>
                        <a:rPr lang="en-IN" sz="10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Fst</a:t>
                      </a:r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err="1" smtClean="0">
                          <a:latin typeface="Arial" pitchFamily="34" charset="0"/>
                          <a:cs typeface="Arial" pitchFamily="34" charset="0"/>
                        </a:rPr>
                        <a:t>Follistatin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75815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29223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Ncor2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Nuclear receptor co-repressor 2 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89469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23854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Igf1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 Insulin-like growth factor 1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89764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19425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</a:t>
                      </a:r>
                      <a:r>
                        <a:rPr lang="en-IN" sz="10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Maff</a:t>
                      </a:r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v-</a:t>
                      </a:r>
                      <a:r>
                        <a:rPr lang="en-IN" sz="1000" dirty="0" err="1" smtClean="0">
                          <a:latin typeface="Arial" pitchFamily="34" charset="0"/>
                          <a:cs typeface="Arial" pitchFamily="34" charset="0"/>
                        </a:rPr>
                        <a:t>maf</a:t>
                      </a:r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IN" sz="1000" dirty="0" err="1" smtClean="0">
                          <a:latin typeface="Arial" pitchFamily="34" charset="0"/>
                          <a:cs typeface="Arial" pitchFamily="34" charset="0"/>
                        </a:rPr>
                        <a:t>musculoaponeurotic</a:t>
                      </a:r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IN" sz="1000" dirty="0" err="1" smtClean="0">
                          <a:latin typeface="Arial" pitchFamily="34" charset="0"/>
                          <a:cs typeface="Arial" pitchFamily="34" charset="0"/>
                        </a:rPr>
                        <a:t>fibrosarcoma</a:t>
                      </a:r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 oncogene homolog F (avian)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0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8521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18998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Bmp7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Bone morphogenetic protein 7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86719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16632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Ncoa2 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Nuclear receptor </a:t>
                      </a:r>
                      <a:r>
                        <a:rPr lang="en-IN" sz="1000" dirty="0" err="1" smtClean="0">
                          <a:latin typeface="Arial" pitchFamily="34" charset="0"/>
                          <a:cs typeface="Arial" pitchFamily="34" charset="0"/>
                        </a:rPr>
                        <a:t>coactivator</a:t>
                      </a:r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 2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89946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16057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Igfbp6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Insulin-like growth factor binding protein 6</a:t>
                      </a:r>
                    </a:p>
                    <a:p>
                      <a:pPr algn="ctr"/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73796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15042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Erbb2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v-erb-b2 </a:t>
                      </a:r>
                      <a:r>
                        <a:rPr lang="en-IN" sz="1000" dirty="0" err="1" smtClean="0">
                          <a:latin typeface="Arial" pitchFamily="34" charset="0"/>
                          <a:cs typeface="Arial" pitchFamily="34" charset="0"/>
                        </a:rPr>
                        <a:t>erythroblastic</a:t>
                      </a:r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IN" sz="1000" dirty="0" err="1" smtClean="0">
                          <a:latin typeface="Arial" pitchFamily="34" charset="0"/>
                          <a:cs typeface="Arial" pitchFamily="34" charset="0"/>
                        </a:rPr>
                        <a:t>leukemia</a:t>
                      </a:r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 viral oncogene homolog 2, </a:t>
                      </a:r>
                      <a:r>
                        <a:rPr lang="en-IN" sz="1000" dirty="0" err="1" smtClean="0">
                          <a:latin typeface="Arial" pitchFamily="34" charset="0"/>
                          <a:cs typeface="Arial" pitchFamily="34" charset="0"/>
                        </a:rPr>
                        <a:t>neuro</a:t>
                      </a:r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/</a:t>
                      </a:r>
                      <a:r>
                        <a:rPr lang="en-IN" sz="1000" dirty="0" err="1" smtClean="0">
                          <a:latin typeface="Arial" pitchFamily="34" charset="0"/>
                          <a:cs typeface="Arial" pitchFamily="34" charset="0"/>
                        </a:rPr>
                        <a:t>glioblastoma</a:t>
                      </a:r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 derived oncogene homolog (avian)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4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77396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1348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Xbp1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X-box binding protein 1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smtClean="0">
                          <a:latin typeface="Arial" pitchFamily="34" charset="0"/>
                          <a:cs typeface="Arial" pitchFamily="34" charset="0"/>
                        </a:rPr>
                        <a:t>15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74444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11592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Pelp1 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err="1" smtClean="0">
                          <a:latin typeface="Arial" pitchFamily="34" charset="0"/>
                          <a:cs typeface="Arial" pitchFamily="34" charset="0"/>
                        </a:rPr>
                        <a:t>Proline</a:t>
                      </a:r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, glutamic acid and </a:t>
                      </a:r>
                      <a:r>
                        <a:rPr lang="en-IN" sz="1000" dirty="0" err="1" smtClean="0">
                          <a:latin typeface="Arial" pitchFamily="34" charset="0"/>
                          <a:cs typeface="Arial" pitchFamily="34" charset="0"/>
                        </a:rPr>
                        <a:t>leucine</a:t>
                      </a:r>
                      <a:r>
                        <a:rPr lang="en-IN" sz="1000" dirty="0" smtClean="0">
                          <a:latin typeface="Arial" pitchFamily="34" charset="0"/>
                          <a:cs typeface="Arial" pitchFamily="34" charset="0"/>
                        </a:rPr>
                        <a:t> rich protein 1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775648" y="193344"/>
            <a:ext cx="769154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b="1" dirty="0" smtClean="0">
                <a:latin typeface="Arial" pitchFamily="34" charset="0"/>
                <a:cs typeface="Arial" pitchFamily="34" charset="0"/>
              </a:rPr>
              <a:t>Supplemental Table 5. Top 15 UP regulated E</a:t>
            </a:r>
            <a:r>
              <a:rPr lang="en-US" sz="1000" b="1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responsive genes post vehicle (D16) </a:t>
            </a:r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vs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treatment (D16, 96 h AI) </a:t>
            </a:r>
            <a:endParaRPr lang="en-IN" sz="1000" b="1" dirty="0" smtClean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03</Words>
  <Application>Microsoft Office PowerPoint</Application>
  <PresentationFormat>On-screen Show (4:3)</PresentationFormat>
  <Paragraphs>8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iis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uresh</dc:creator>
  <cp:lastModifiedBy>user</cp:lastModifiedBy>
  <cp:revision>2</cp:revision>
  <dcterms:created xsi:type="dcterms:W3CDTF">2016-02-22T05:14:19Z</dcterms:created>
  <dcterms:modified xsi:type="dcterms:W3CDTF">2016-02-22T10:33:30Z</dcterms:modified>
</cp:coreProperties>
</file>